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wmf" ContentType="image/x-wmf"/>
  <Override PartName="/ppt/media/image2.wmf" ContentType="image/x-wmf"/>
  <Override PartName="/ppt/media/image3.wmf" ContentType="image/x-wmf"/>
  <Override PartName="/ppt/media/image4.wmf" ContentType="image/x-wmf"/>
  <Override PartName="/ppt/media/image5.wmf" ContentType="image/x-wmf"/>
  <Override PartName="/ppt/media/image6.wmf" ContentType="image/x-wmf"/>
  <Override PartName="/ppt/media/image7.wmf" ContentType="image/x-wmf"/>
  <Override PartName="/ppt/media/image8.wmf" ContentType="image/x-wmf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504363" cy="7578725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78B3A30-DFE3-4F14-8741-35F3F4E44C01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74840" y="303120"/>
            <a:ext cx="8555040" cy="1263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74840" y="1767960"/>
            <a:ext cx="8555040" cy="2385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74840" y="4380840"/>
            <a:ext cx="8555040" cy="2385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F36AF21-1706-44E2-88D4-02F13D769CD2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74840" y="303120"/>
            <a:ext cx="8555040" cy="1263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74840" y="1767960"/>
            <a:ext cx="4174560" cy="2385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858560" y="1767960"/>
            <a:ext cx="4174560" cy="2385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74840" y="4380840"/>
            <a:ext cx="4174560" cy="2385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858560" y="4380840"/>
            <a:ext cx="4174560" cy="2385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A241B1D-E4B2-4C1B-962C-863698FA0152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74840" y="303120"/>
            <a:ext cx="8555040" cy="1263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74840" y="1767960"/>
            <a:ext cx="2754360" cy="2385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367440" y="1767960"/>
            <a:ext cx="2754360" cy="2385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259680" y="1767960"/>
            <a:ext cx="2754360" cy="2385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74840" y="4380840"/>
            <a:ext cx="2754360" cy="2385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367440" y="4380840"/>
            <a:ext cx="2754360" cy="2385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259680" y="4380840"/>
            <a:ext cx="2754360" cy="2385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8AA7892-9551-4C5F-A7ED-4FDC70494403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74840" y="303120"/>
            <a:ext cx="8555040" cy="1263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74840" y="1767960"/>
            <a:ext cx="8555040" cy="50022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7921CD9-D5EF-4443-842A-73EB2EBAC8EC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74840" y="303120"/>
            <a:ext cx="8555040" cy="1263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74840" y="1767960"/>
            <a:ext cx="8555040" cy="5002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C73485A-ECE4-4EDA-8452-05A2980BDAFD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74840" y="303120"/>
            <a:ext cx="8555040" cy="1263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74840" y="1767960"/>
            <a:ext cx="4174560" cy="5002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858560" y="1767960"/>
            <a:ext cx="4174560" cy="5002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E8A765B-766A-448F-A778-E2C4A5057E1D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74840" y="303120"/>
            <a:ext cx="8555040" cy="1263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5FB4F5E-7FC5-45CA-B744-96DD605847FD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74840" y="303120"/>
            <a:ext cx="8555040" cy="58586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4EC0C48-765A-4C01-BE57-14F877913709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74840" y="303120"/>
            <a:ext cx="8555040" cy="1263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74840" y="1767960"/>
            <a:ext cx="4174560" cy="2385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858560" y="1767960"/>
            <a:ext cx="4174560" cy="5002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74840" y="4380840"/>
            <a:ext cx="4174560" cy="2385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9B0A536-362C-4568-93AB-2BA62A9C49B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74840" y="303120"/>
            <a:ext cx="8555040" cy="1263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74840" y="1767960"/>
            <a:ext cx="4174560" cy="5002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858560" y="1767960"/>
            <a:ext cx="4174560" cy="2385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858560" y="4380840"/>
            <a:ext cx="4174560" cy="2385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F65663D-9994-46B3-9337-E7169D7E641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74840" y="303120"/>
            <a:ext cx="8555040" cy="1263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74840" y="1767960"/>
            <a:ext cx="4174560" cy="2385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858560" y="1767960"/>
            <a:ext cx="4174560" cy="2385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74840" y="4380840"/>
            <a:ext cx="8555040" cy="2385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BF67999-4C9D-4561-865F-82C322FB3AF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74840" y="303120"/>
            <a:ext cx="8555040" cy="1263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74840" y="1767960"/>
            <a:ext cx="8555040" cy="5002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74840" y="7023240"/>
            <a:ext cx="2217600" cy="403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zh-TW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21DB7B20-1020-420B-B49D-B53FC21EA680}" type="datetime">
              <a:rPr b="0" lang="zh-TW" sz="1200" spc="-1" strike="noStrike">
                <a:solidFill>
                  <a:srgbClr val="898989"/>
                </a:solidFill>
                <a:latin typeface="Calibri"/>
              </a:rPr>
              <a:t>115/08/29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247560" y="7023240"/>
            <a:ext cx="3008520" cy="403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811560" y="7023240"/>
            <a:ext cx="2217960" cy="403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zh-TW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7EC05267-6312-43F9-853F-409E0B50E88F}" type="slidenum">
              <a:rPr b="0" lang="zh-TW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wmf"/><Relationship Id="rId2" Type="http://schemas.openxmlformats.org/officeDocument/2006/relationships/image" Target="../media/image2.wmf"/><Relationship Id="rId3" Type="http://schemas.openxmlformats.org/officeDocument/2006/relationships/image" Target="../media/image3.wmf"/><Relationship Id="rId4" Type="http://schemas.openxmlformats.org/officeDocument/2006/relationships/image" Target="../media/image4.wmf"/><Relationship Id="rId5" Type="http://schemas.openxmlformats.org/officeDocument/2006/relationships/image" Target="../media/image5.wmf"/><Relationship Id="rId6" Type="http://schemas.openxmlformats.org/officeDocument/2006/relationships/image" Target="../media/image6.wmf"/><Relationship Id="rId7" Type="http://schemas.openxmlformats.org/officeDocument/2006/relationships/image" Target="../media/image7.wmf"/><Relationship Id="rId8" Type="http://schemas.openxmlformats.org/officeDocument/2006/relationships/image" Target="../media/image8.wmf"/><Relationship Id="rId9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Picture 9" descr=""/>
          <p:cNvPicPr/>
          <p:nvPr/>
        </p:nvPicPr>
        <p:blipFill>
          <a:blip r:embed="rId1"/>
          <a:stretch/>
        </p:blipFill>
        <p:spPr>
          <a:xfrm>
            <a:off x="422280" y="4854600"/>
            <a:ext cx="2013120" cy="2112840"/>
          </a:xfrm>
          <a:prstGeom prst="rect">
            <a:avLst/>
          </a:prstGeom>
          <a:ln w="0">
            <a:noFill/>
          </a:ln>
        </p:spPr>
      </p:pic>
      <p:pic>
        <p:nvPicPr>
          <p:cNvPr id="42" name="Picture 10" descr=""/>
          <p:cNvPicPr/>
          <p:nvPr/>
        </p:nvPicPr>
        <p:blipFill>
          <a:blip r:embed="rId2"/>
          <a:stretch/>
        </p:blipFill>
        <p:spPr>
          <a:xfrm>
            <a:off x="5337000" y="4870440"/>
            <a:ext cx="2014560" cy="2111400"/>
          </a:xfrm>
          <a:prstGeom prst="rect">
            <a:avLst/>
          </a:prstGeom>
          <a:ln w="0">
            <a:noFill/>
          </a:ln>
        </p:spPr>
      </p:pic>
      <p:sp>
        <p:nvSpPr>
          <p:cNvPr id="43" name="Text Box 10"/>
          <p:cNvSpPr/>
          <p:nvPr/>
        </p:nvSpPr>
        <p:spPr>
          <a:xfrm>
            <a:off x="119160" y="6977160"/>
            <a:ext cx="9385200" cy="641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just"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Figure S2. Different immune cells were identified in uterine edema fluids of C3H/He and C57BL/6 mice. FACS analysis of edema fluid from (A) C3H/He and (B) C57BL/6 mouse uteri using F4/80, GR1, CD11b, CD3ε, and B220 markers. Result showed that edema fluid from C3H/He uterus contained a large amount of GR1+/CD11b+ myeloid cells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44" name="Group 45"/>
          <p:cNvGrpSpPr/>
          <p:nvPr/>
        </p:nvGrpSpPr>
        <p:grpSpPr>
          <a:xfrm>
            <a:off x="495360" y="6622560"/>
            <a:ext cx="288360" cy="308160"/>
            <a:chOff x="495360" y="6622560"/>
            <a:chExt cx="288360" cy="308160"/>
          </a:xfrm>
        </p:grpSpPr>
        <p:sp>
          <p:nvSpPr>
            <p:cNvPr id="45" name="Line 46"/>
            <p:cNvSpPr/>
            <p:nvPr/>
          </p:nvSpPr>
          <p:spPr>
            <a:xfrm flipV="1">
              <a:off x="508320" y="6622560"/>
              <a:ext cx="0" cy="30780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" name="Line 47"/>
            <p:cNvSpPr/>
            <p:nvPr/>
          </p:nvSpPr>
          <p:spPr>
            <a:xfrm>
              <a:off x="495360" y="6930720"/>
              <a:ext cx="288360" cy="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47" name="Group 48"/>
          <p:cNvGrpSpPr/>
          <p:nvPr/>
        </p:nvGrpSpPr>
        <p:grpSpPr>
          <a:xfrm>
            <a:off x="5402160" y="6635880"/>
            <a:ext cx="288720" cy="306000"/>
            <a:chOff x="5402160" y="6635880"/>
            <a:chExt cx="288720" cy="306000"/>
          </a:xfrm>
        </p:grpSpPr>
        <p:sp>
          <p:nvSpPr>
            <p:cNvPr id="48" name="Line 49"/>
            <p:cNvSpPr/>
            <p:nvPr/>
          </p:nvSpPr>
          <p:spPr>
            <a:xfrm flipV="1">
              <a:off x="5415120" y="6635880"/>
              <a:ext cx="0" cy="30600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" name="Line 50"/>
            <p:cNvSpPr/>
            <p:nvPr/>
          </p:nvSpPr>
          <p:spPr>
            <a:xfrm>
              <a:off x="5402160" y="6941880"/>
              <a:ext cx="288720" cy="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50" name="Rectangle 62"/>
          <p:cNvSpPr/>
          <p:nvPr/>
        </p:nvSpPr>
        <p:spPr>
          <a:xfrm>
            <a:off x="1015920" y="6832440"/>
            <a:ext cx="1201680" cy="9864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Rectangle 63"/>
          <p:cNvSpPr/>
          <p:nvPr/>
        </p:nvSpPr>
        <p:spPr>
          <a:xfrm>
            <a:off x="5952960" y="6870600"/>
            <a:ext cx="1202040" cy="9684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Rectangle 71"/>
          <p:cNvSpPr/>
          <p:nvPr/>
        </p:nvSpPr>
        <p:spPr>
          <a:xfrm>
            <a:off x="423720" y="5122800"/>
            <a:ext cx="92160" cy="15001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Rectangle 72"/>
          <p:cNvSpPr/>
          <p:nvPr/>
        </p:nvSpPr>
        <p:spPr>
          <a:xfrm>
            <a:off x="5354640" y="5122800"/>
            <a:ext cx="92160" cy="15001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54" name="Group 91"/>
          <p:cNvGrpSpPr/>
          <p:nvPr/>
        </p:nvGrpSpPr>
        <p:grpSpPr>
          <a:xfrm>
            <a:off x="12600" y="-20520"/>
            <a:ext cx="8330760" cy="2450160"/>
            <a:chOff x="12600" y="-20520"/>
            <a:chExt cx="8330760" cy="2450160"/>
          </a:xfrm>
        </p:grpSpPr>
        <p:pic>
          <p:nvPicPr>
            <p:cNvPr id="55" name="Picture 3" descr=""/>
            <p:cNvPicPr/>
            <p:nvPr/>
          </p:nvPicPr>
          <p:blipFill>
            <a:blip r:embed="rId3"/>
            <a:srcRect l="0" t="0" r="0" b="5896"/>
            <a:stretch/>
          </p:blipFill>
          <p:spPr>
            <a:xfrm>
              <a:off x="381960" y="117720"/>
              <a:ext cx="2072520" cy="198684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56" name="Picture 4" descr=""/>
            <p:cNvPicPr/>
            <p:nvPr/>
          </p:nvPicPr>
          <p:blipFill>
            <a:blip r:embed="rId4"/>
            <a:srcRect l="0" t="0" r="0" b="5236"/>
            <a:stretch/>
          </p:blipFill>
          <p:spPr>
            <a:xfrm>
              <a:off x="5274720" y="102600"/>
              <a:ext cx="2072160" cy="200196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57" name="Text Box 13"/>
            <p:cNvSpPr/>
            <p:nvPr/>
          </p:nvSpPr>
          <p:spPr>
            <a:xfrm>
              <a:off x="12600" y="-20520"/>
              <a:ext cx="58104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1125"/>
                </a:spcBef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1800" spc="-1" strike="noStrike">
                  <a:solidFill>
                    <a:srgbClr val="000000"/>
                  </a:solidFill>
                  <a:latin typeface="Arial"/>
                </a:rPr>
                <a:t>A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" name="Text Box 14"/>
            <p:cNvSpPr/>
            <p:nvPr/>
          </p:nvSpPr>
          <p:spPr>
            <a:xfrm>
              <a:off x="4976280" y="-5040"/>
              <a:ext cx="58068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1125"/>
                </a:spcBef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1800" spc="-1" strike="noStrike">
                  <a:solidFill>
                    <a:srgbClr val="000000"/>
                  </a:solidFill>
                  <a:latin typeface="Arial"/>
                </a:rPr>
                <a:t>B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" name="Rectangle 15"/>
            <p:cNvSpPr/>
            <p:nvPr/>
          </p:nvSpPr>
          <p:spPr>
            <a:xfrm>
              <a:off x="765000" y="1416240"/>
              <a:ext cx="542880" cy="520200"/>
            </a:xfrm>
            <a:prstGeom prst="rect">
              <a:avLst/>
            </a:prstGeom>
            <a:noFill/>
            <a:ln w="2844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0" name="Rectangle 16"/>
            <p:cNvSpPr/>
            <p:nvPr/>
          </p:nvSpPr>
          <p:spPr>
            <a:xfrm>
              <a:off x="5649480" y="1389960"/>
              <a:ext cx="542880" cy="518040"/>
            </a:xfrm>
            <a:prstGeom prst="rect">
              <a:avLst/>
            </a:prstGeom>
            <a:noFill/>
            <a:ln w="2844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1" name="Line 17"/>
            <p:cNvSpPr/>
            <p:nvPr/>
          </p:nvSpPr>
          <p:spPr>
            <a:xfrm>
              <a:off x="5926680" y="2006640"/>
              <a:ext cx="0" cy="208440"/>
            </a:xfrm>
            <a:prstGeom prst="line">
              <a:avLst/>
            </a:prstGeom>
            <a:ln w="28440">
              <a:solidFill>
                <a:srgbClr val="ff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2" name="Line 18"/>
            <p:cNvSpPr/>
            <p:nvPr/>
          </p:nvSpPr>
          <p:spPr>
            <a:xfrm>
              <a:off x="989280" y="2006640"/>
              <a:ext cx="0" cy="208440"/>
            </a:xfrm>
            <a:prstGeom prst="line">
              <a:avLst/>
            </a:prstGeom>
            <a:ln w="28440">
              <a:solidFill>
                <a:srgbClr val="ff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3" name="Rectangle 19"/>
            <p:cNvSpPr/>
            <p:nvPr/>
          </p:nvSpPr>
          <p:spPr>
            <a:xfrm>
              <a:off x="756720" y="139320"/>
              <a:ext cx="542880" cy="1235520"/>
            </a:xfrm>
            <a:prstGeom prst="rect">
              <a:avLst/>
            </a:prstGeom>
            <a:noFill/>
            <a:ln w="2844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4" name="Rectangle 20"/>
            <p:cNvSpPr/>
            <p:nvPr/>
          </p:nvSpPr>
          <p:spPr>
            <a:xfrm>
              <a:off x="5649480" y="102600"/>
              <a:ext cx="542880" cy="1235520"/>
            </a:xfrm>
            <a:prstGeom prst="rect">
              <a:avLst/>
            </a:prstGeom>
            <a:noFill/>
            <a:ln w="2844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65" name="Group 24"/>
            <p:cNvGrpSpPr/>
            <p:nvPr/>
          </p:nvGrpSpPr>
          <p:grpSpPr>
            <a:xfrm>
              <a:off x="1517400" y="959760"/>
              <a:ext cx="1992960" cy="1218240"/>
              <a:chOff x="1517400" y="959760"/>
              <a:chExt cx="1992960" cy="1218240"/>
            </a:xfrm>
          </p:grpSpPr>
          <p:sp>
            <p:nvSpPr>
              <p:cNvPr id="66" name="Line 22"/>
              <p:cNvSpPr/>
              <p:nvPr/>
            </p:nvSpPr>
            <p:spPr>
              <a:xfrm>
                <a:off x="3510360" y="959760"/>
                <a:ext cx="0" cy="1218240"/>
              </a:xfrm>
              <a:prstGeom prst="line">
                <a:avLst/>
              </a:prstGeom>
              <a:ln w="28440">
                <a:solidFill>
                  <a:srgbClr val="ff0000"/>
                </a:solidFill>
                <a:miter/>
                <a:tailEnd len="med" type="triangle" w="med"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7" name="Line 23"/>
              <p:cNvSpPr/>
              <p:nvPr/>
            </p:nvSpPr>
            <p:spPr>
              <a:xfrm flipH="1">
                <a:off x="1517400" y="959760"/>
                <a:ext cx="1992960" cy="0"/>
              </a:xfrm>
              <a:prstGeom prst="line">
                <a:avLst/>
              </a:prstGeom>
              <a:ln w="28440">
                <a:solidFill>
                  <a:srgbClr val="ff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68" name="Group 26"/>
            <p:cNvGrpSpPr/>
            <p:nvPr/>
          </p:nvGrpSpPr>
          <p:grpSpPr>
            <a:xfrm>
              <a:off x="6350400" y="956160"/>
              <a:ext cx="1992960" cy="1218240"/>
              <a:chOff x="6350400" y="956160"/>
              <a:chExt cx="1992960" cy="1218240"/>
            </a:xfrm>
          </p:grpSpPr>
          <p:sp>
            <p:nvSpPr>
              <p:cNvPr id="69" name="Line 27"/>
              <p:cNvSpPr/>
              <p:nvPr/>
            </p:nvSpPr>
            <p:spPr>
              <a:xfrm>
                <a:off x="8343360" y="956160"/>
                <a:ext cx="0" cy="1218240"/>
              </a:xfrm>
              <a:prstGeom prst="line">
                <a:avLst/>
              </a:prstGeom>
              <a:ln w="28440">
                <a:solidFill>
                  <a:srgbClr val="ff0000"/>
                </a:solidFill>
                <a:miter/>
                <a:tailEnd len="med" type="triangle" w="med"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0" name="Line 28"/>
              <p:cNvSpPr/>
              <p:nvPr/>
            </p:nvSpPr>
            <p:spPr>
              <a:xfrm flipH="1">
                <a:off x="6350400" y="956160"/>
                <a:ext cx="1992960" cy="0"/>
              </a:xfrm>
              <a:prstGeom prst="line">
                <a:avLst/>
              </a:prstGeom>
              <a:ln w="28440">
                <a:solidFill>
                  <a:srgbClr val="ff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71" name="Group 35"/>
            <p:cNvGrpSpPr/>
            <p:nvPr/>
          </p:nvGrpSpPr>
          <p:grpSpPr>
            <a:xfrm>
              <a:off x="369000" y="2021760"/>
              <a:ext cx="288000" cy="306000"/>
              <a:chOff x="369000" y="2021760"/>
              <a:chExt cx="288000" cy="306000"/>
            </a:xfrm>
          </p:grpSpPr>
          <p:sp>
            <p:nvSpPr>
              <p:cNvPr id="72" name="Line 33"/>
              <p:cNvSpPr/>
              <p:nvPr/>
            </p:nvSpPr>
            <p:spPr>
              <a:xfrm flipV="1">
                <a:off x="381960" y="2021760"/>
                <a:ext cx="0" cy="306000"/>
              </a:xfrm>
              <a:prstGeom prst="line">
                <a:avLst/>
              </a:prstGeom>
              <a:ln w="28440">
                <a:solidFill>
                  <a:srgbClr val="000000"/>
                </a:solidFill>
                <a:miter/>
                <a:tailEnd len="med" type="triangle" w="med"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3" name="Line 34"/>
              <p:cNvSpPr/>
              <p:nvPr/>
            </p:nvSpPr>
            <p:spPr>
              <a:xfrm>
                <a:off x="369000" y="2327760"/>
                <a:ext cx="288000" cy="0"/>
              </a:xfrm>
              <a:prstGeom prst="line">
                <a:avLst/>
              </a:prstGeom>
              <a:ln w="28440">
                <a:solidFill>
                  <a:srgbClr val="000000"/>
                </a:solidFill>
                <a:miter/>
                <a:tailEnd len="med" type="triangle" w="med"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74" name="Group 36"/>
            <p:cNvGrpSpPr/>
            <p:nvPr/>
          </p:nvGrpSpPr>
          <p:grpSpPr>
            <a:xfrm>
              <a:off x="5360400" y="2034360"/>
              <a:ext cx="288360" cy="306720"/>
              <a:chOff x="5360400" y="2034360"/>
              <a:chExt cx="288360" cy="306720"/>
            </a:xfrm>
          </p:grpSpPr>
          <p:sp>
            <p:nvSpPr>
              <p:cNvPr id="75" name="Line 37"/>
              <p:cNvSpPr/>
              <p:nvPr/>
            </p:nvSpPr>
            <p:spPr>
              <a:xfrm flipV="1">
                <a:off x="5373360" y="2034360"/>
                <a:ext cx="0" cy="306360"/>
              </a:xfrm>
              <a:prstGeom prst="line">
                <a:avLst/>
              </a:prstGeom>
              <a:ln w="28440">
                <a:solidFill>
                  <a:srgbClr val="000000"/>
                </a:solidFill>
                <a:miter/>
                <a:tailEnd len="med" type="triangle" w="med"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6" name="Line 38"/>
              <p:cNvSpPr/>
              <p:nvPr/>
            </p:nvSpPr>
            <p:spPr>
              <a:xfrm>
                <a:off x="5360400" y="2341080"/>
                <a:ext cx="288360" cy="0"/>
              </a:xfrm>
              <a:prstGeom prst="line">
                <a:avLst/>
              </a:prstGeom>
              <a:ln w="28440">
                <a:solidFill>
                  <a:srgbClr val="000000"/>
                </a:solidFill>
                <a:miter/>
                <a:tailEnd len="med" type="triangle" w="med"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77" name="Rectangle 64"/>
            <p:cNvSpPr/>
            <p:nvPr/>
          </p:nvSpPr>
          <p:spPr>
            <a:xfrm>
              <a:off x="381960" y="207720"/>
              <a:ext cx="92160" cy="150048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8" name="Rectangle 66"/>
            <p:cNvSpPr/>
            <p:nvPr/>
          </p:nvSpPr>
          <p:spPr>
            <a:xfrm>
              <a:off x="5281560" y="376200"/>
              <a:ext cx="91800" cy="150012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9" name="Text Box 80"/>
            <p:cNvSpPr/>
            <p:nvPr/>
          </p:nvSpPr>
          <p:spPr>
            <a:xfrm>
              <a:off x="78480" y="1741320"/>
              <a:ext cx="14385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FSC-A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0" name="Text Box 81"/>
            <p:cNvSpPr/>
            <p:nvPr/>
          </p:nvSpPr>
          <p:spPr>
            <a:xfrm>
              <a:off x="632880" y="2183400"/>
              <a:ext cx="14389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624"/>
                </a:spcBef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F4/8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1" name="Text Box 82"/>
            <p:cNvSpPr/>
            <p:nvPr/>
          </p:nvSpPr>
          <p:spPr>
            <a:xfrm>
              <a:off x="5631120" y="2175120"/>
              <a:ext cx="14389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624"/>
                </a:spcBef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F4/8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2" name="Text Box 83"/>
            <p:cNvSpPr/>
            <p:nvPr/>
          </p:nvSpPr>
          <p:spPr>
            <a:xfrm>
              <a:off x="5009040" y="1773360"/>
              <a:ext cx="14385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624"/>
                </a:spcBef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FSC-A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83" name="Group 90"/>
          <p:cNvGrpSpPr/>
          <p:nvPr/>
        </p:nvGrpSpPr>
        <p:grpSpPr>
          <a:xfrm>
            <a:off x="119160" y="2519280"/>
            <a:ext cx="9219600" cy="2301480"/>
            <a:chOff x="119160" y="2519280"/>
            <a:chExt cx="9219600" cy="2301480"/>
          </a:xfrm>
        </p:grpSpPr>
        <p:pic>
          <p:nvPicPr>
            <p:cNvPr id="84" name="Picture 5" descr=""/>
            <p:cNvPicPr/>
            <p:nvPr/>
          </p:nvPicPr>
          <p:blipFill>
            <a:blip r:embed="rId5"/>
            <a:srcRect l="0" t="0" r="0" b="3569"/>
            <a:stretch/>
          </p:blipFill>
          <p:spPr>
            <a:xfrm>
              <a:off x="2514600" y="2583720"/>
              <a:ext cx="2012760" cy="203868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85" name="Picture 6" descr=""/>
            <p:cNvPicPr/>
            <p:nvPr/>
          </p:nvPicPr>
          <p:blipFill>
            <a:blip r:embed="rId6"/>
            <a:srcRect l="0" t="0" r="0" b="3908"/>
            <a:stretch/>
          </p:blipFill>
          <p:spPr>
            <a:xfrm>
              <a:off x="7324560" y="2519280"/>
              <a:ext cx="2012760" cy="203184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86" name="Picture 8" descr=""/>
            <p:cNvPicPr/>
            <p:nvPr/>
          </p:nvPicPr>
          <p:blipFill>
            <a:blip r:embed="rId7"/>
            <a:srcRect l="0" t="0" r="0" b="3569"/>
            <a:stretch/>
          </p:blipFill>
          <p:spPr>
            <a:xfrm>
              <a:off x="435600" y="2583720"/>
              <a:ext cx="2012760" cy="203868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87" name="Line 43"/>
            <p:cNvSpPr/>
            <p:nvPr/>
          </p:nvSpPr>
          <p:spPr>
            <a:xfrm flipV="1">
              <a:off x="5373720" y="4398840"/>
              <a:ext cx="0" cy="30708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8" name="Line 51"/>
            <p:cNvSpPr/>
            <p:nvPr/>
          </p:nvSpPr>
          <p:spPr>
            <a:xfrm flipV="1">
              <a:off x="5373720" y="4398840"/>
              <a:ext cx="0" cy="30708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9" name="Rectangle 58"/>
            <p:cNvSpPr/>
            <p:nvPr/>
          </p:nvSpPr>
          <p:spPr>
            <a:xfrm>
              <a:off x="990000" y="4574520"/>
              <a:ext cx="1200960" cy="9828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0" name="Rectangle 59"/>
            <p:cNvSpPr/>
            <p:nvPr/>
          </p:nvSpPr>
          <p:spPr>
            <a:xfrm>
              <a:off x="3088800" y="4587840"/>
              <a:ext cx="1200960" cy="9828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1" name="Rectangle 60"/>
            <p:cNvSpPr/>
            <p:nvPr/>
          </p:nvSpPr>
          <p:spPr>
            <a:xfrm>
              <a:off x="5927040" y="4587840"/>
              <a:ext cx="1200960" cy="9828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2" name="Rectangle 61"/>
            <p:cNvSpPr/>
            <p:nvPr/>
          </p:nvSpPr>
          <p:spPr>
            <a:xfrm>
              <a:off x="7743600" y="4587840"/>
              <a:ext cx="1200960" cy="9828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3" name="Rectangle 67"/>
            <p:cNvSpPr/>
            <p:nvPr/>
          </p:nvSpPr>
          <p:spPr>
            <a:xfrm>
              <a:off x="435600" y="2898000"/>
              <a:ext cx="92160" cy="150120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4" name="Rectangle 68"/>
            <p:cNvSpPr/>
            <p:nvPr/>
          </p:nvSpPr>
          <p:spPr>
            <a:xfrm>
              <a:off x="2514600" y="2590560"/>
              <a:ext cx="92160" cy="150156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5" name="Rectangle 69"/>
            <p:cNvSpPr/>
            <p:nvPr/>
          </p:nvSpPr>
          <p:spPr>
            <a:xfrm>
              <a:off x="5327640" y="2898000"/>
              <a:ext cx="92160" cy="150120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6" name="Rectangle 70"/>
            <p:cNvSpPr/>
            <p:nvPr/>
          </p:nvSpPr>
          <p:spPr>
            <a:xfrm>
              <a:off x="7347240" y="2898000"/>
              <a:ext cx="92160" cy="150120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7" name="Line 52"/>
            <p:cNvSpPr/>
            <p:nvPr/>
          </p:nvSpPr>
          <p:spPr>
            <a:xfrm>
              <a:off x="5360760" y="4706280"/>
              <a:ext cx="3192480" cy="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98" name="Group 76"/>
            <p:cNvGrpSpPr/>
            <p:nvPr/>
          </p:nvGrpSpPr>
          <p:grpSpPr>
            <a:xfrm>
              <a:off x="397800" y="4399200"/>
              <a:ext cx="3192120" cy="306720"/>
              <a:chOff x="397800" y="4399200"/>
              <a:chExt cx="3192120" cy="306720"/>
            </a:xfrm>
          </p:grpSpPr>
          <p:sp>
            <p:nvSpPr>
              <p:cNvPr id="99" name="Line 77"/>
              <p:cNvSpPr/>
              <p:nvPr/>
            </p:nvSpPr>
            <p:spPr>
              <a:xfrm flipV="1">
                <a:off x="410760" y="4399200"/>
                <a:ext cx="0" cy="306720"/>
              </a:xfrm>
              <a:prstGeom prst="line">
                <a:avLst/>
              </a:prstGeom>
              <a:ln w="28440">
                <a:solidFill>
                  <a:srgbClr val="000000"/>
                </a:solidFill>
                <a:miter/>
                <a:tailEnd len="med" type="triangle" w="med"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0" name="Line 78"/>
              <p:cNvSpPr/>
              <p:nvPr/>
            </p:nvSpPr>
            <p:spPr>
              <a:xfrm>
                <a:off x="397800" y="4705920"/>
                <a:ext cx="3192120" cy="0"/>
              </a:xfrm>
              <a:prstGeom prst="line">
                <a:avLst/>
              </a:prstGeom>
              <a:ln w="28440">
                <a:solidFill>
                  <a:srgbClr val="000000"/>
                </a:solidFill>
                <a:miter/>
                <a:tailEnd len="med" type="triangle" w="med"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pic>
          <p:nvPicPr>
            <p:cNvPr id="101" name="Picture 7" descr=""/>
            <p:cNvPicPr/>
            <p:nvPr/>
          </p:nvPicPr>
          <p:blipFill>
            <a:blip r:embed="rId8"/>
            <a:srcRect l="0" t="0" r="0" b="3899"/>
            <a:stretch/>
          </p:blipFill>
          <p:spPr>
            <a:xfrm>
              <a:off x="5373720" y="2519280"/>
              <a:ext cx="2012760" cy="203184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102" name="Text Box 84"/>
            <p:cNvSpPr/>
            <p:nvPr/>
          </p:nvSpPr>
          <p:spPr>
            <a:xfrm>
              <a:off x="5082120" y="4155480"/>
              <a:ext cx="5806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624"/>
                </a:spcBef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GR1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3" name="Text Box 85"/>
            <p:cNvSpPr/>
            <p:nvPr/>
          </p:nvSpPr>
          <p:spPr>
            <a:xfrm>
              <a:off x="8553600" y="4551120"/>
              <a:ext cx="7851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624"/>
                </a:spcBef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CD11b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4" name="Rectangle 86"/>
            <p:cNvSpPr/>
            <p:nvPr/>
          </p:nvSpPr>
          <p:spPr>
            <a:xfrm>
              <a:off x="5887080" y="4517640"/>
              <a:ext cx="1200960" cy="9864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5" name="Rectangle 87"/>
            <p:cNvSpPr/>
            <p:nvPr/>
          </p:nvSpPr>
          <p:spPr>
            <a:xfrm>
              <a:off x="7933320" y="4504320"/>
              <a:ext cx="1200960" cy="9828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6" name="Text Box 88"/>
            <p:cNvSpPr/>
            <p:nvPr/>
          </p:nvSpPr>
          <p:spPr>
            <a:xfrm>
              <a:off x="3590640" y="4574520"/>
              <a:ext cx="7851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624"/>
                </a:spcBef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CD11b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7" name="Text Box 89"/>
            <p:cNvSpPr/>
            <p:nvPr/>
          </p:nvSpPr>
          <p:spPr>
            <a:xfrm>
              <a:off x="119160" y="4183920"/>
              <a:ext cx="5806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624"/>
                </a:spcBef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GR1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108" name="Text Box 92"/>
          <p:cNvSpPr/>
          <p:nvPr/>
        </p:nvSpPr>
        <p:spPr>
          <a:xfrm>
            <a:off x="752400" y="6791400"/>
            <a:ext cx="6732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B22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9" name="Text Box 93"/>
          <p:cNvSpPr/>
          <p:nvPr/>
        </p:nvSpPr>
        <p:spPr>
          <a:xfrm>
            <a:off x="5668920" y="6802560"/>
            <a:ext cx="6732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B22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0" name="Text Box 94"/>
          <p:cNvSpPr/>
          <p:nvPr/>
        </p:nvSpPr>
        <p:spPr>
          <a:xfrm>
            <a:off x="27000" y="6378480"/>
            <a:ext cx="6732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CD3ε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1" name="Text Box 95"/>
          <p:cNvSpPr/>
          <p:nvPr/>
        </p:nvSpPr>
        <p:spPr>
          <a:xfrm>
            <a:off x="4944960" y="6378480"/>
            <a:ext cx="6732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CD3ε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06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4-08-20T00:05:59Z</dcterms:created>
  <dc:creator>u0557754</dc:creator>
  <dc:description/>
  <dc:language>en-US</dc:language>
  <cp:lastModifiedBy>CROFT</cp:lastModifiedBy>
  <dcterms:modified xsi:type="dcterms:W3CDTF">2014-11-26T23:48:41Z</dcterms:modified>
  <cp:revision>11</cp:revision>
  <dc:subject/>
  <dc:title>Slide 1</dc:title>
</cp:coreProperties>
</file>